
<file path=[Content_Types].xml><?xml version="1.0" encoding="utf-8"?>
<Types xmlns="http://schemas.openxmlformats.org/package/2006/content-types">
  <Default Extension="xml" ContentType="application/xml"/>
  <Default Extension="jpeg" ContentType="image/jpeg"/>
  <Default Extension="bin" ContentType="application/vnd.openxmlformats-officedocument.presentationml.printerSettings"/>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drawings/drawing1.xml" ContentType="application/vnd.openxmlformats-officedocument.drawingml.chartshape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3"/>
  </p:notesMasterIdLst>
  <p:sldIdLst>
    <p:sldId id="262" r:id="rId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2659" autoAdjust="0"/>
  </p:normalViewPr>
  <p:slideViewPr>
    <p:cSldViewPr snapToGrid="0" snapToObjects="1">
      <p:cViewPr>
        <p:scale>
          <a:sx n="100" d="100"/>
          <a:sy n="100" d="100"/>
        </p:scale>
        <p:origin x="-1264" y="-232"/>
      </p:cViewPr>
      <p:guideLst>
        <p:guide orient="horz" pos="243"/>
        <p:guide/>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4" Type="http://schemas.openxmlformats.org/officeDocument/2006/relationships/printerSettings" Target="printerSettings/printerSettings1.bin"/><Relationship Id="rId5" Type="http://schemas.openxmlformats.org/officeDocument/2006/relationships/presProps" Target="presProps.xml"/><Relationship Id="rId6" Type="http://schemas.openxmlformats.org/officeDocument/2006/relationships/viewProps" Target="viewProps.xml"/><Relationship Id="rId7" Type="http://schemas.openxmlformats.org/officeDocument/2006/relationships/theme" Target="theme/theme1.xml"/><Relationship Id="rId8"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s>
</file>

<file path=ppt/charts/_rels/chart1.xml.rels><?xml version="1.0" encoding="UTF-8" standalone="yes"?>
<Relationships xmlns="http://schemas.openxmlformats.org/package/2006/relationships"><Relationship Id="rId1" Type="http://schemas.openxmlformats.org/officeDocument/2006/relationships/oleObject" Target="hort$:Lin%20Tian:Documents:RNAseq.latest.analysis:GOseq.result.of.photo.DE.genes.0417.xlsx" TargetMode="External"/><Relationship Id="rId2" Type="http://schemas.openxmlformats.org/officeDocument/2006/relationships/chartUserShapes" Target="../drawings/drawing1.xml"/></Relationships>
</file>

<file path=ppt/charts/chart1.xml><?xml version="1.0" encoding="utf-8"?>
<c:chartSpace xmlns:c="http://schemas.openxmlformats.org/drawingml/2006/chart" xmlns:a="http://schemas.openxmlformats.org/drawingml/2006/main" xmlns:r="http://schemas.openxmlformats.org/officeDocument/2006/relationships">
  <c:date1904 val="1"/>
  <c:lang val="en-US"/>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manualLayout>
          <c:layoutTarget val="inner"/>
          <c:xMode val="edge"/>
          <c:yMode val="edge"/>
          <c:x val="0.354789093737633"/>
          <c:y val="0.0352781546811397"/>
          <c:w val="0.616688410049264"/>
          <c:h val="0.89593863182299"/>
        </c:manualLayout>
      </c:layout>
      <c:barChart>
        <c:barDir val="bar"/>
        <c:grouping val="clustered"/>
        <c:varyColors val="0"/>
        <c:ser>
          <c:idx val="0"/>
          <c:order val="0"/>
          <c:tx>
            <c:v>ratio in DE genes</c:v>
          </c:tx>
          <c:invertIfNegative val="0"/>
          <c:cat>
            <c:strRef>
              <c:f>BP!$H$2:$H$21</c:f>
              <c:strCache>
                <c:ptCount val="20"/>
                <c:pt idx="0">
                  <c:v>response to salt stress</c:v>
                </c:pt>
                <c:pt idx="1">
                  <c:v>response to cadmium ion</c:v>
                </c:pt>
                <c:pt idx="2">
                  <c:v>oxidation-reduction process</c:v>
                </c:pt>
                <c:pt idx="3">
                  <c:v>response to cold</c:v>
                </c:pt>
                <c:pt idx="4">
                  <c:v>isopentenyl diphosphate biosynthetic process, mevalonate-independent pathway</c:v>
                </c:pt>
                <c:pt idx="5">
                  <c:v>response to abscisic acid stimulus</c:v>
                </c:pt>
                <c:pt idx="6">
                  <c:v>cysteine biosynthetic process</c:v>
                </c:pt>
                <c:pt idx="7">
                  <c:v>response to heat</c:v>
                </c:pt>
                <c:pt idx="8">
                  <c:v>response to high light intensity</c:v>
                </c:pt>
                <c:pt idx="9">
                  <c:v>protein folding</c:v>
                </c:pt>
                <c:pt idx="10">
                  <c:v>thylakoid membrane organization</c:v>
                </c:pt>
                <c:pt idx="11">
                  <c:v>Golgi organization</c:v>
                </c:pt>
                <c:pt idx="12">
                  <c:v>pentose-phosphate shunt</c:v>
                </c:pt>
                <c:pt idx="13">
                  <c:v>response to fructose stimulus</c:v>
                </c:pt>
                <c:pt idx="14">
                  <c:v>response to blue light</c:v>
                </c:pt>
                <c:pt idx="15">
                  <c:v>defense response to fungus</c:v>
                </c:pt>
                <c:pt idx="16">
                  <c:v>response to sucrose stimulus</c:v>
                </c:pt>
                <c:pt idx="17">
                  <c:v>regulation of meristem growth</c:v>
                </c:pt>
                <c:pt idx="18">
                  <c:v>response to water deprivation</c:v>
                </c:pt>
                <c:pt idx="19">
                  <c:v>response to hydrogen peroxide</c:v>
                </c:pt>
              </c:strCache>
            </c:strRef>
          </c:cat>
          <c:val>
            <c:numRef>
              <c:f>BP!$J$2:$J$21</c:f>
              <c:numCache>
                <c:formatCode>General</c:formatCode>
                <c:ptCount val="20"/>
                <c:pt idx="0">
                  <c:v>0.0450781968721251</c:v>
                </c:pt>
                <c:pt idx="1">
                  <c:v>0.0409801789746592</c:v>
                </c:pt>
                <c:pt idx="2">
                  <c:v>0.0626411307184076</c:v>
                </c:pt>
                <c:pt idx="3">
                  <c:v>0.0302751526302584</c:v>
                </c:pt>
                <c:pt idx="4">
                  <c:v>0.0136321819854479</c:v>
                </c:pt>
                <c:pt idx="5">
                  <c:v>0.02584260265953</c:v>
                </c:pt>
                <c:pt idx="6">
                  <c:v>0.0138830810403947</c:v>
                </c:pt>
                <c:pt idx="7">
                  <c:v>0.0137158150037635</c:v>
                </c:pt>
                <c:pt idx="8">
                  <c:v>0.0135485489671322</c:v>
                </c:pt>
                <c:pt idx="9">
                  <c:v>0.0163920715898637</c:v>
                </c:pt>
                <c:pt idx="10">
                  <c:v>0.0114577235092414</c:v>
                </c:pt>
                <c:pt idx="11">
                  <c:v>0.0150539432968136</c:v>
                </c:pt>
                <c:pt idx="12">
                  <c:v>0.0122104206740821</c:v>
                </c:pt>
                <c:pt idx="13">
                  <c:v>0.0116249895458727</c:v>
                </c:pt>
                <c:pt idx="14">
                  <c:v>0.00894873295977252</c:v>
                </c:pt>
                <c:pt idx="15">
                  <c:v>0.0168102366814418</c:v>
                </c:pt>
                <c:pt idx="16">
                  <c:v>0.0144685121686042</c:v>
                </c:pt>
                <c:pt idx="17">
                  <c:v>0.011792255582504</c:v>
                </c:pt>
                <c:pt idx="18">
                  <c:v>0.0208246215605921</c:v>
                </c:pt>
                <c:pt idx="19">
                  <c:v>0.0120431546374509</c:v>
                </c:pt>
              </c:numCache>
            </c:numRef>
          </c:val>
        </c:ser>
        <c:ser>
          <c:idx val="1"/>
          <c:order val="1"/>
          <c:tx>
            <c:v>ratio in genome</c:v>
          </c:tx>
          <c:invertIfNegative val="0"/>
          <c:cat>
            <c:strRef>
              <c:f>BP!$H$2:$H$21</c:f>
              <c:strCache>
                <c:ptCount val="20"/>
                <c:pt idx="0">
                  <c:v>response to salt stress</c:v>
                </c:pt>
                <c:pt idx="1">
                  <c:v>response to cadmium ion</c:v>
                </c:pt>
                <c:pt idx="2">
                  <c:v>oxidation-reduction process</c:v>
                </c:pt>
                <c:pt idx="3">
                  <c:v>response to cold</c:v>
                </c:pt>
                <c:pt idx="4">
                  <c:v>isopentenyl diphosphate biosynthetic process, mevalonate-independent pathway</c:v>
                </c:pt>
                <c:pt idx="5">
                  <c:v>response to abscisic acid stimulus</c:v>
                </c:pt>
                <c:pt idx="6">
                  <c:v>cysteine biosynthetic process</c:v>
                </c:pt>
                <c:pt idx="7">
                  <c:v>response to heat</c:v>
                </c:pt>
                <c:pt idx="8">
                  <c:v>response to high light intensity</c:v>
                </c:pt>
                <c:pt idx="9">
                  <c:v>protein folding</c:v>
                </c:pt>
                <c:pt idx="10">
                  <c:v>thylakoid membrane organization</c:v>
                </c:pt>
                <c:pt idx="11">
                  <c:v>Golgi organization</c:v>
                </c:pt>
                <c:pt idx="12">
                  <c:v>pentose-phosphate shunt</c:v>
                </c:pt>
                <c:pt idx="13">
                  <c:v>response to fructose stimulus</c:v>
                </c:pt>
                <c:pt idx="14">
                  <c:v>response to blue light</c:v>
                </c:pt>
                <c:pt idx="15">
                  <c:v>defense response to fungus</c:v>
                </c:pt>
                <c:pt idx="16">
                  <c:v>response to sucrose stimulus</c:v>
                </c:pt>
                <c:pt idx="17">
                  <c:v>regulation of meristem growth</c:v>
                </c:pt>
                <c:pt idx="18">
                  <c:v>response to water deprivation</c:v>
                </c:pt>
                <c:pt idx="19">
                  <c:v>response to hydrogen peroxide</c:v>
                </c:pt>
              </c:strCache>
            </c:strRef>
          </c:cat>
          <c:val>
            <c:numRef>
              <c:f>BP!$K$2:$K$21</c:f>
              <c:numCache>
                <c:formatCode>General</c:formatCode>
                <c:ptCount val="20"/>
                <c:pt idx="0">
                  <c:v>0.0263400635441222</c:v>
                </c:pt>
                <c:pt idx="1">
                  <c:v>0.0239827815927027</c:v>
                </c:pt>
                <c:pt idx="2">
                  <c:v>0.0417392641180691</c:v>
                </c:pt>
                <c:pt idx="3">
                  <c:v>0.0166803320692836</c:v>
                </c:pt>
                <c:pt idx="4">
                  <c:v>0.00663626114584401</c:v>
                </c:pt>
                <c:pt idx="5">
                  <c:v>0.0157322947627344</c:v>
                </c:pt>
                <c:pt idx="6">
                  <c:v>0.00725120426360561</c:v>
                </c:pt>
                <c:pt idx="7">
                  <c:v>0.00722558163369888</c:v>
                </c:pt>
                <c:pt idx="8">
                  <c:v>0.00712309111407195</c:v>
                </c:pt>
                <c:pt idx="9">
                  <c:v>0.00912165624679717</c:v>
                </c:pt>
                <c:pt idx="10">
                  <c:v>0.0057138464692016</c:v>
                </c:pt>
                <c:pt idx="11">
                  <c:v>0.00822486420006149</c:v>
                </c:pt>
                <c:pt idx="12">
                  <c:v>0.006251921697243</c:v>
                </c:pt>
                <c:pt idx="13">
                  <c:v>0.00597007276826893</c:v>
                </c:pt>
                <c:pt idx="14">
                  <c:v>0.00415086604489085</c:v>
                </c:pt>
                <c:pt idx="15">
                  <c:v>0.00968535410474531</c:v>
                </c:pt>
                <c:pt idx="16">
                  <c:v>0.00796863790099416</c:v>
                </c:pt>
                <c:pt idx="17">
                  <c:v>0.00612380854770933</c:v>
                </c:pt>
                <c:pt idx="18">
                  <c:v>0.0127344470636466</c:v>
                </c:pt>
                <c:pt idx="19">
                  <c:v>0.0063287895869632</c:v>
                </c:pt>
              </c:numCache>
            </c:numRef>
          </c:val>
        </c:ser>
        <c:dLbls>
          <c:showLegendKey val="0"/>
          <c:showVal val="0"/>
          <c:showCatName val="0"/>
          <c:showSerName val="0"/>
          <c:showPercent val="0"/>
          <c:showBubbleSize val="0"/>
        </c:dLbls>
        <c:gapWidth val="150"/>
        <c:axId val="2078937864"/>
        <c:axId val="2118154312"/>
      </c:barChart>
      <c:catAx>
        <c:axId val="2078937864"/>
        <c:scaling>
          <c:orientation val="minMax"/>
        </c:scaling>
        <c:delete val="0"/>
        <c:axPos val="l"/>
        <c:majorTickMark val="out"/>
        <c:minorTickMark val="none"/>
        <c:tickLblPos val="nextTo"/>
        <c:crossAx val="2118154312"/>
        <c:crosses val="autoZero"/>
        <c:auto val="1"/>
        <c:lblAlgn val="ctr"/>
        <c:lblOffset val="100"/>
        <c:noMultiLvlLbl val="0"/>
      </c:catAx>
      <c:valAx>
        <c:axId val="2118154312"/>
        <c:scaling>
          <c:orientation val="minMax"/>
        </c:scaling>
        <c:delete val="0"/>
        <c:axPos val="b"/>
        <c:majorGridlines>
          <c:spPr>
            <a:ln>
              <a:noFill/>
            </a:ln>
          </c:spPr>
        </c:majorGridlines>
        <c:numFmt formatCode="General" sourceLinked="1"/>
        <c:majorTickMark val="out"/>
        <c:minorTickMark val="none"/>
        <c:tickLblPos val="nextTo"/>
        <c:crossAx val="2078937864"/>
        <c:crosses val="autoZero"/>
        <c:crossBetween val="between"/>
      </c:valAx>
    </c:plotArea>
    <c:plotVisOnly val="1"/>
    <c:dispBlanksAs val="gap"/>
    <c:showDLblsOverMax val="0"/>
  </c:chart>
  <c:externalData r:id="rId1">
    <c:autoUpdate val="0"/>
  </c:externalData>
  <c:userShapes r:id="rId2"/>
</c:chartSpace>
</file>

<file path=ppt/drawings/drawing1.xml><?xml version="1.0" encoding="utf-8"?>
<c:userShapes xmlns:c="http://schemas.openxmlformats.org/drawingml/2006/chart">
  <cdr:relSizeAnchor xmlns:cdr="http://schemas.openxmlformats.org/drawingml/2006/chartDrawing">
    <cdr:from>
      <cdr:x>0.68444</cdr:x>
      <cdr:y>0.12121</cdr:y>
    </cdr:from>
    <cdr:to>
      <cdr:x>0.89948</cdr:x>
      <cdr:y>0.25932</cdr:y>
    </cdr:to>
    <cdr:sp macro="" textlink="">
      <cdr:nvSpPr>
        <cdr:cNvPr id="2" name="TextBox 1"/>
        <cdr:cNvSpPr txBox="1"/>
      </cdr:nvSpPr>
      <cdr:spPr>
        <a:xfrm xmlns:a="http://schemas.openxmlformats.org/drawingml/2006/main">
          <a:off x="5015507" y="567256"/>
          <a:ext cx="1575793" cy="646331"/>
        </a:xfrm>
        <a:prstGeom xmlns:a="http://schemas.openxmlformats.org/drawingml/2006/main" prst="rect">
          <a:avLst/>
        </a:prstGeom>
        <a:noFill xmlns:a="http://schemas.openxmlformats.org/drawingml/2006/main"/>
      </cdr:spPr>
      <cdr:txBody>
        <a:bodyPr xmlns:a="http://schemas.openxmlformats.org/drawingml/2006/main" wrap="square" rtlCol="0">
          <a:spAutoFit/>
        </a:bodyPr>
        <a:lstStyle xmlns:a="http://schemas.openxmlformats.org/drawingml/2006/main">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xmlns:a="http://schemas.openxmlformats.org/drawingml/2006/main">
          <a:pPr marL="171450" indent="-171450">
            <a:buFont typeface="Wingdings" charset="0"/>
            <a:buChar char="n"/>
          </a:pPr>
          <a:r>
            <a:rPr lang="en-US" sz="1200" b="1" dirty="0" smtClean="0">
              <a:solidFill>
                <a:srgbClr val="FF6600"/>
              </a:solidFill>
              <a:ea typeface="Wingdings"/>
              <a:cs typeface="Wingdings"/>
              <a:sym typeface="Wingdings"/>
            </a:rPr>
            <a:t> </a:t>
          </a:r>
          <a:r>
            <a:rPr lang="en-US" sz="1200" b="1" dirty="0" smtClean="0">
              <a:ea typeface="Wingdings"/>
              <a:cs typeface="Wingdings"/>
              <a:sym typeface="Wingdings"/>
            </a:rPr>
            <a:t>Ratio</a:t>
          </a:r>
          <a:r>
            <a:rPr lang="en-US" sz="1200" b="1" dirty="0" smtClean="0">
              <a:solidFill>
                <a:schemeClr val="tx1"/>
              </a:solidFill>
              <a:ea typeface="Wingdings"/>
              <a:cs typeface="Wingdings"/>
              <a:sym typeface="Wingdings"/>
            </a:rPr>
            <a:t> in genome</a:t>
          </a:r>
        </a:p>
        <a:p xmlns:a="http://schemas.openxmlformats.org/drawingml/2006/main">
          <a:pPr marL="171450" indent="-171450">
            <a:buFont typeface="Wingdings" charset="0"/>
            <a:buChar char="n"/>
          </a:pPr>
          <a:endParaRPr lang="en-US" sz="1200" b="1" dirty="0">
            <a:solidFill>
              <a:schemeClr val="tx1"/>
            </a:solidFill>
            <a:ea typeface="Wingdings"/>
            <a:cs typeface="Wingdings"/>
            <a:sym typeface="Wingdings"/>
          </a:endParaRPr>
        </a:p>
        <a:p xmlns:a="http://schemas.openxmlformats.org/drawingml/2006/main">
          <a:pPr marL="171450" indent="-171450">
            <a:buFont typeface="Wingdings" charset="0"/>
            <a:buChar char="n"/>
          </a:pPr>
          <a:r>
            <a:rPr lang="en-US" sz="1200" dirty="0" smtClean="0">
              <a:solidFill>
                <a:schemeClr val="tx2">
                  <a:lumMod val="60000"/>
                  <a:lumOff val="40000"/>
                </a:schemeClr>
              </a:solidFill>
              <a:ea typeface="Wingdings"/>
              <a:cs typeface="Wingdings"/>
              <a:sym typeface="Wingdings"/>
            </a:rPr>
            <a:t> </a:t>
          </a:r>
          <a:r>
            <a:rPr lang="en-US" sz="1200" b="1" dirty="0" smtClean="0">
              <a:solidFill>
                <a:schemeClr val="tx1"/>
              </a:solidFill>
              <a:ea typeface="Wingdings"/>
              <a:cs typeface="Wingdings"/>
              <a:sym typeface="Wingdings"/>
            </a:rPr>
            <a:t>Ratio in DE genes</a:t>
          </a:r>
          <a:endParaRPr lang="en-US" sz="1200" b="1" dirty="0" smtClean="0">
            <a:solidFill>
              <a:schemeClr val="tx1"/>
            </a:solidFill>
          </a:endParaRPr>
        </a:p>
      </cdr:txBody>
    </cdr:sp>
  </cdr:relSizeAnchor>
</c:userShape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3C01273F-F4BC-4C44-9788-34192E244855}" type="datetimeFigureOut">
              <a:rPr lang="en-US" smtClean="0"/>
              <a:t>10/1/14</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8F9F143A-5920-AB45-A74D-05287F4F46A2}" type="slidenum">
              <a:rPr lang="en-US" smtClean="0"/>
              <a:t>‹#›</a:t>
            </a:fld>
            <a:endParaRPr lang="en-US"/>
          </a:p>
        </p:txBody>
      </p:sp>
    </p:spTree>
    <p:extLst>
      <p:ext uri="{BB962C8B-B14F-4D97-AF65-F5344CB8AC3E}">
        <p14:creationId xmlns:p14="http://schemas.microsoft.com/office/powerpoint/2010/main" val="1893613041"/>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10"/>
          </p:nvPr>
        </p:nvSpPr>
        <p:spPr/>
        <p:txBody>
          <a:bodyPr/>
          <a:lstStyle/>
          <a:p>
            <a:fld id="{7386FD56-43BD-C649-A160-981ABCB2D949}" type="slidenum">
              <a:rPr lang="en-US" smtClean="0"/>
              <a:t>1</a:t>
            </a:fld>
            <a:endParaRPr lang="en-US"/>
          </a:p>
        </p:txBody>
      </p:sp>
    </p:spTree>
    <p:extLst>
      <p:ext uri="{BB962C8B-B14F-4D97-AF65-F5344CB8AC3E}">
        <p14:creationId xmlns:p14="http://schemas.microsoft.com/office/powerpoint/2010/main" val="23238970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2E796BE3-420F-8F41-9769-130A60F9F022}" type="datetimeFigureOut">
              <a:rPr lang="en-US" smtClean="0"/>
              <a:t>10/1/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48DDB1A-797B-A449-B09E-F7DFAE71F05F}" type="slidenum">
              <a:rPr lang="en-US" smtClean="0"/>
              <a:t>‹#›</a:t>
            </a:fld>
            <a:endParaRPr lang="en-US"/>
          </a:p>
        </p:txBody>
      </p:sp>
    </p:spTree>
    <p:extLst>
      <p:ext uri="{BB962C8B-B14F-4D97-AF65-F5344CB8AC3E}">
        <p14:creationId xmlns:p14="http://schemas.microsoft.com/office/powerpoint/2010/main" val="73398201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2E796BE3-420F-8F41-9769-130A60F9F022}" type="datetimeFigureOut">
              <a:rPr lang="en-US" smtClean="0"/>
              <a:t>10/1/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48DDB1A-797B-A449-B09E-F7DFAE71F05F}" type="slidenum">
              <a:rPr lang="en-US" smtClean="0"/>
              <a:t>‹#›</a:t>
            </a:fld>
            <a:endParaRPr lang="en-US"/>
          </a:p>
        </p:txBody>
      </p:sp>
    </p:spTree>
    <p:extLst>
      <p:ext uri="{BB962C8B-B14F-4D97-AF65-F5344CB8AC3E}">
        <p14:creationId xmlns:p14="http://schemas.microsoft.com/office/powerpoint/2010/main" val="17085170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2E796BE3-420F-8F41-9769-130A60F9F022}" type="datetimeFigureOut">
              <a:rPr lang="en-US" smtClean="0"/>
              <a:t>10/1/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48DDB1A-797B-A449-B09E-F7DFAE71F05F}" type="slidenum">
              <a:rPr lang="en-US" smtClean="0"/>
              <a:t>‹#›</a:t>
            </a:fld>
            <a:endParaRPr lang="en-US"/>
          </a:p>
        </p:txBody>
      </p:sp>
    </p:spTree>
    <p:extLst>
      <p:ext uri="{BB962C8B-B14F-4D97-AF65-F5344CB8AC3E}">
        <p14:creationId xmlns:p14="http://schemas.microsoft.com/office/powerpoint/2010/main" val="424011612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2E796BE3-420F-8F41-9769-130A60F9F022}" type="datetimeFigureOut">
              <a:rPr lang="en-US" smtClean="0"/>
              <a:t>10/1/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48DDB1A-797B-A449-B09E-F7DFAE71F05F}" type="slidenum">
              <a:rPr lang="en-US" smtClean="0"/>
              <a:t>‹#›</a:t>
            </a:fld>
            <a:endParaRPr lang="en-US"/>
          </a:p>
        </p:txBody>
      </p:sp>
    </p:spTree>
    <p:extLst>
      <p:ext uri="{BB962C8B-B14F-4D97-AF65-F5344CB8AC3E}">
        <p14:creationId xmlns:p14="http://schemas.microsoft.com/office/powerpoint/2010/main" val="43170275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2E796BE3-420F-8F41-9769-130A60F9F022}" type="datetimeFigureOut">
              <a:rPr lang="en-US" smtClean="0"/>
              <a:t>10/1/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48DDB1A-797B-A449-B09E-F7DFAE71F05F}" type="slidenum">
              <a:rPr lang="en-US" smtClean="0"/>
              <a:t>‹#›</a:t>
            </a:fld>
            <a:endParaRPr lang="en-US"/>
          </a:p>
        </p:txBody>
      </p:sp>
    </p:spTree>
    <p:extLst>
      <p:ext uri="{BB962C8B-B14F-4D97-AF65-F5344CB8AC3E}">
        <p14:creationId xmlns:p14="http://schemas.microsoft.com/office/powerpoint/2010/main" val="7275600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2E796BE3-420F-8F41-9769-130A60F9F022}" type="datetimeFigureOut">
              <a:rPr lang="en-US" smtClean="0"/>
              <a:t>10/1/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48DDB1A-797B-A449-B09E-F7DFAE71F05F}" type="slidenum">
              <a:rPr lang="en-US" smtClean="0"/>
              <a:t>‹#›</a:t>
            </a:fld>
            <a:endParaRPr lang="en-US"/>
          </a:p>
        </p:txBody>
      </p:sp>
    </p:spTree>
    <p:extLst>
      <p:ext uri="{BB962C8B-B14F-4D97-AF65-F5344CB8AC3E}">
        <p14:creationId xmlns:p14="http://schemas.microsoft.com/office/powerpoint/2010/main" val="174473784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2E796BE3-420F-8F41-9769-130A60F9F022}" type="datetimeFigureOut">
              <a:rPr lang="en-US" smtClean="0"/>
              <a:t>10/1/1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48DDB1A-797B-A449-B09E-F7DFAE71F05F}" type="slidenum">
              <a:rPr lang="en-US" smtClean="0"/>
              <a:t>‹#›</a:t>
            </a:fld>
            <a:endParaRPr lang="en-US"/>
          </a:p>
        </p:txBody>
      </p:sp>
    </p:spTree>
    <p:extLst>
      <p:ext uri="{BB962C8B-B14F-4D97-AF65-F5344CB8AC3E}">
        <p14:creationId xmlns:p14="http://schemas.microsoft.com/office/powerpoint/2010/main" val="10783834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2E796BE3-420F-8F41-9769-130A60F9F022}" type="datetimeFigureOut">
              <a:rPr lang="en-US" smtClean="0"/>
              <a:t>10/1/1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48DDB1A-797B-A449-B09E-F7DFAE71F05F}" type="slidenum">
              <a:rPr lang="en-US" smtClean="0"/>
              <a:t>‹#›</a:t>
            </a:fld>
            <a:endParaRPr lang="en-US"/>
          </a:p>
        </p:txBody>
      </p:sp>
    </p:spTree>
    <p:extLst>
      <p:ext uri="{BB962C8B-B14F-4D97-AF65-F5344CB8AC3E}">
        <p14:creationId xmlns:p14="http://schemas.microsoft.com/office/powerpoint/2010/main" val="61430823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E796BE3-420F-8F41-9769-130A60F9F022}" type="datetimeFigureOut">
              <a:rPr lang="en-US" smtClean="0"/>
              <a:t>10/1/1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48DDB1A-797B-A449-B09E-F7DFAE71F05F}" type="slidenum">
              <a:rPr lang="en-US" smtClean="0"/>
              <a:t>‹#›</a:t>
            </a:fld>
            <a:endParaRPr lang="en-US"/>
          </a:p>
        </p:txBody>
      </p:sp>
    </p:spTree>
    <p:extLst>
      <p:ext uri="{BB962C8B-B14F-4D97-AF65-F5344CB8AC3E}">
        <p14:creationId xmlns:p14="http://schemas.microsoft.com/office/powerpoint/2010/main" val="153637675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2E796BE3-420F-8F41-9769-130A60F9F022}" type="datetimeFigureOut">
              <a:rPr lang="en-US" smtClean="0"/>
              <a:t>10/1/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48DDB1A-797B-A449-B09E-F7DFAE71F05F}" type="slidenum">
              <a:rPr lang="en-US" smtClean="0"/>
              <a:t>‹#›</a:t>
            </a:fld>
            <a:endParaRPr lang="en-US"/>
          </a:p>
        </p:txBody>
      </p:sp>
    </p:spTree>
    <p:extLst>
      <p:ext uri="{BB962C8B-B14F-4D97-AF65-F5344CB8AC3E}">
        <p14:creationId xmlns:p14="http://schemas.microsoft.com/office/powerpoint/2010/main" val="336224663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2E796BE3-420F-8F41-9769-130A60F9F022}" type="datetimeFigureOut">
              <a:rPr lang="en-US" smtClean="0"/>
              <a:t>10/1/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48DDB1A-797B-A449-B09E-F7DFAE71F05F}" type="slidenum">
              <a:rPr lang="en-US" smtClean="0"/>
              <a:t>‹#›</a:t>
            </a:fld>
            <a:endParaRPr lang="en-US"/>
          </a:p>
        </p:txBody>
      </p:sp>
    </p:spTree>
    <p:extLst>
      <p:ext uri="{BB962C8B-B14F-4D97-AF65-F5344CB8AC3E}">
        <p14:creationId xmlns:p14="http://schemas.microsoft.com/office/powerpoint/2010/main" val="1669008522"/>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E796BE3-420F-8F41-9769-130A60F9F022}" type="datetimeFigureOut">
              <a:rPr lang="en-US" smtClean="0"/>
              <a:t>10/1/14</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48DDB1A-797B-A449-B09E-F7DFAE71F05F}" type="slidenum">
              <a:rPr lang="en-US" smtClean="0"/>
              <a:t>‹#›</a:t>
            </a:fld>
            <a:endParaRPr lang="en-US"/>
          </a:p>
        </p:txBody>
      </p:sp>
    </p:spTree>
    <p:extLst>
      <p:ext uri="{BB962C8B-B14F-4D97-AF65-F5344CB8AC3E}">
        <p14:creationId xmlns:p14="http://schemas.microsoft.com/office/powerpoint/2010/main" val="53507859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6.xml"/><Relationship Id="rId2" Type="http://schemas.openxmlformats.org/officeDocument/2006/relationships/notesSlide" Target="../notesSlides/notesSlide1.xml"/><Relationship Id="rId3" Type="http://schemas.openxmlformats.org/officeDocument/2006/relationships/chart" Target="../charts/char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558800" y="5379809"/>
            <a:ext cx="7861300" cy="1200329"/>
          </a:xfrm>
          <a:prstGeom prst="rect">
            <a:avLst/>
          </a:prstGeom>
          <a:noFill/>
        </p:spPr>
        <p:txBody>
          <a:bodyPr wrap="square" rtlCol="0">
            <a:spAutoFit/>
          </a:bodyPr>
          <a:lstStyle/>
          <a:p>
            <a:r>
              <a:rPr lang="en-US" sz="1200" b="1" dirty="0"/>
              <a:t>Figure S4. Top twenty over-represented GO terms for biological processes in differentially expressed (DE) photoperiod genes. </a:t>
            </a:r>
            <a:r>
              <a:rPr lang="en-US" sz="1200" dirty="0"/>
              <a:t>GO terms involved with DE genes between long- and short-day </a:t>
            </a:r>
            <a:r>
              <a:rPr lang="en-US" sz="1200" dirty="0" smtClean="0"/>
              <a:t>treatments </a:t>
            </a:r>
            <a:r>
              <a:rPr lang="en-US" sz="1200" dirty="0"/>
              <a:t>were analyzed with </a:t>
            </a:r>
            <a:r>
              <a:rPr lang="en-US" sz="1200" dirty="0" err="1"/>
              <a:t>Goseq</a:t>
            </a:r>
            <a:r>
              <a:rPr lang="en-US" sz="1200" dirty="0"/>
              <a:t> [61] to compare their enrichment in DE genes compared with whole genome. The p-value was adjusted with BH method </a:t>
            </a:r>
            <a:r>
              <a:rPr lang="en-US" sz="1200"/>
              <a:t>[</a:t>
            </a:r>
            <a:r>
              <a:rPr lang="en-US" sz="1200" smtClean="0"/>
              <a:t>95]</a:t>
            </a:r>
            <a:r>
              <a:rPr lang="en-US" sz="1200" dirty="0"/>
              <a:t>.The over-represented genes were defined with adjusted p-value smaller than 0.05. The ratio of each GO term is calculated by comparing the number of genes involved with each GO term with number of genes in the whole group. </a:t>
            </a:r>
          </a:p>
          <a:p>
            <a:endParaRPr lang="en-US" sz="1200" dirty="0"/>
          </a:p>
        </p:txBody>
      </p:sp>
      <p:graphicFrame>
        <p:nvGraphicFramePr>
          <p:cNvPr id="4" name="Chart 3"/>
          <p:cNvGraphicFramePr>
            <a:graphicFrameLocks/>
          </p:cNvGraphicFramePr>
          <p:nvPr>
            <p:extLst>
              <p:ext uri="{D42A27DB-BD31-4B8C-83A1-F6EECF244321}">
                <p14:modId xmlns:p14="http://schemas.microsoft.com/office/powerpoint/2010/main" val="804360660"/>
              </p:ext>
            </p:extLst>
          </p:nvPr>
        </p:nvGraphicFramePr>
        <p:xfrm>
          <a:off x="742950" y="415925"/>
          <a:ext cx="7327900" cy="4679950"/>
        </p:xfrm>
        <a:graphic>
          <a:graphicData uri="http://schemas.openxmlformats.org/drawingml/2006/chart">
            <c:chart xmlns:c="http://schemas.openxmlformats.org/drawingml/2006/chart" xmlns:r="http://schemas.openxmlformats.org/officeDocument/2006/relationships" r:id="rId3"/>
          </a:graphicData>
        </a:graphic>
      </p:graphicFrame>
    </p:spTree>
    <p:extLst>
      <p:ext uri="{BB962C8B-B14F-4D97-AF65-F5344CB8AC3E}">
        <p14:creationId xmlns:p14="http://schemas.microsoft.com/office/powerpoint/2010/main" val="3348506768"/>
      </p:ext>
    </p:extLst>
  </p:cSld>
  <p:clrMapOvr>
    <a:masterClrMapping/>
  </p:clrMapOvr>
  <p:timing>
    <p:tnLst>
      <p:par>
        <p:cTn xmlns:p14="http://schemas.microsoft.com/office/powerpoint/2010/mai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1331</TotalTime>
  <Words>122</Words>
  <Application>Microsoft Macintosh PowerPoint</Application>
  <PresentationFormat>On-screen Show (4:3)</PresentationFormat>
  <Paragraphs>5</Paragraphs>
  <Slides>1</Slides>
  <Notes>1</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ry figures</dc:title>
  <dc:creator>Tian Lin</dc:creator>
  <cp:lastModifiedBy/>
  <cp:revision>26</cp:revision>
  <dcterms:created xsi:type="dcterms:W3CDTF">2014-05-27T17:03:52Z</dcterms:created>
  <dcterms:modified xsi:type="dcterms:W3CDTF">2014-10-01T20:07:51Z</dcterms:modified>
</cp:coreProperties>
</file>